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52" d="100"/>
          <a:sy n="52" d="100"/>
        </p:scale>
        <p:origin x="235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ss Greenberg" userId="1284d08b09a98a81" providerId="LiveId" clId="{920115F4-8FDD-4D81-A0DF-246337F077F8}"/>
    <pc:docChg chg="modSld">
      <pc:chgData name="Ross Greenberg" userId="1284d08b09a98a81" providerId="LiveId" clId="{920115F4-8FDD-4D81-A0DF-246337F077F8}" dt="2021-06-10T19:40:30.948" v="3" actId="20577"/>
      <pc:docMkLst>
        <pc:docMk/>
      </pc:docMkLst>
      <pc:sldChg chg="modSp mod">
        <pc:chgData name="Ross Greenberg" userId="1284d08b09a98a81" providerId="LiveId" clId="{920115F4-8FDD-4D81-A0DF-246337F077F8}" dt="2021-06-10T19:40:25.752" v="1" actId="20577"/>
        <pc:sldMkLst>
          <pc:docMk/>
          <pc:sldMk cId="1507966" sldId="256"/>
        </pc:sldMkLst>
        <pc:spChg chg="mod">
          <ac:chgData name="Ross Greenberg" userId="1284d08b09a98a81" providerId="LiveId" clId="{920115F4-8FDD-4D81-A0DF-246337F077F8}" dt="2021-06-10T19:40:25.752" v="1" actId="20577"/>
          <ac:spMkLst>
            <pc:docMk/>
            <pc:sldMk cId="1507966" sldId="256"/>
            <ac:spMk id="5" creationId="{1138AF22-F234-48F3-943B-80369C5180B6}"/>
          </ac:spMkLst>
        </pc:spChg>
      </pc:sldChg>
      <pc:sldChg chg="modSp mod">
        <pc:chgData name="Ross Greenberg" userId="1284d08b09a98a81" providerId="LiveId" clId="{920115F4-8FDD-4D81-A0DF-246337F077F8}" dt="2021-06-10T19:40:30.948" v="3" actId="20577"/>
        <pc:sldMkLst>
          <pc:docMk/>
          <pc:sldMk cId="905368373" sldId="257"/>
        </pc:sldMkLst>
        <pc:spChg chg="mod">
          <ac:chgData name="Ross Greenberg" userId="1284d08b09a98a81" providerId="LiveId" clId="{920115F4-8FDD-4D81-A0DF-246337F077F8}" dt="2021-06-10T19:40:30.948" v="3" actId="20577"/>
          <ac:spMkLst>
            <pc:docMk/>
            <pc:sldMk cId="905368373" sldId="257"/>
            <ac:spMk id="8" creationId="{43AEA0A9-20F2-48D4-89DA-8BEC7DF3A13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284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377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172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060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952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705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312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263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28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977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3159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6C4B2-2305-4CEB-B619-BE9629805ACD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7FAD8-3D14-4F87-904F-02E64D1FD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427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DF77CBA-0563-447F-8CC6-29017D49DB2D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5739" y="2428980"/>
            <a:ext cx="5943600" cy="357060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138AF22-F234-48F3-943B-80369C5180B6}"/>
              </a:ext>
            </a:extLst>
          </p:cNvPr>
          <p:cNvSpPr txBox="1"/>
          <p:nvPr/>
        </p:nvSpPr>
        <p:spPr>
          <a:xfrm>
            <a:off x="914400" y="6055564"/>
            <a:ext cx="5943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1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Local site and systemic adverse reactions in 44 patients with multiple myeloma within 7 days of dose 1 and dose 2 of the SARS-CoV-2 mRNA vaccin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079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9A5EBB6F-C4FE-49E1-8AB9-699D628E2F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980523"/>
              </p:ext>
            </p:extLst>
          </p:nvPr>
        </p:nvGraphicFramePr>
        <p:xfrm>
          <a:off x="1661483" y="1817463"/>
          <a:ext cx="4449431" cy="4956571"/>
        </p:xfrm>
        <a:graphic>
          <a:graphicData uri="http://schemas.openxmlformats.org/drawingml/2006/table">
            <a:tbl>
              <a:tblPr firstRow="1" firstCol="1" bandRow="1"/>
              <a:tblGrid>
                <a:gridCol w="2069092">
                  <a:extLst>
                    <a:ext uri="{9D8B030D-6E8A-4147-A177-3AD203B41FA5}">
                      <a16:colId xmlns:a16="http://schemas.microsoft.com/office/drawing/2014/main" val="2207440105"/>
                    </a:ext>
                  </a:extLst>
                </a:gridCol>
                <a:gridCol w="557063">
                  <a:extLst>
                    <a:ext uri="{9D8B030D-6E8A-4147-A177-3AD203B41FA5}">
                      <a16:colId xmlns:a16="http://schemas.microsoft.com/office/drawing/2014/main" val="1870979352"/>
                    </a:ext>
                  </a:extLst>
                </a:gridCol>
                <a:gridCol w="1823276">
                  <a:extLst>
                    <a:ext uri="{9D8B030D-6E8A-4147-A177-3AD203B41FA5}">
                      <a16:colId xmlns:a16="http://schemas.microsoft.com/office/drawing/2014/main" val="464784620"/>
                    </a:ext>
                  </a:extLst>
                </a:gridCol>
              </a:tblGrid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iter</a:t>
                      </a: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200" baseline="300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median U/mL (IQR)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2328863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verall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239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5337287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ge &gt;55</a:t>
                      </a:r>
                      <a:r>
                        <a:rPr lang="en-US" sz="1200" baseline="300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176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1984755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emale sex</a:t>
                      </a: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&gt;250, &gt;250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7059051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ccine</a:t>
                      </a: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65875765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  Pfizer/BioNTech 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154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9268430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  Moderna 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&gt;250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9880306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erap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6807949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Not on therap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228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2149340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On therapy</a:t>
                      </a:r>
                      <a:r>
                        <a:rPr lang="en-US" sz="120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&gt;250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62141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 Bortezomi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3300723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 Carfilzomi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9139829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 Daratumuma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&gt;250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8632730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 Ixazomi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5 (&lt;0.4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8734902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 Lenalidomid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&gt;250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9671355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 Pomalidomid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250 (202, &gt;250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9860098"/>
                  </a:ext>
                </a:extLst>
              </a:tr>
              <a:tr h="291563">
                <a:tc>
                  <a:txBody>
                    <a:bodyPr/>
                    <a:lstStyle/>
                    <a:p>
                      <a:pPr marL="0" marR="0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 Teclistama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lt;0.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6268900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3AEA0A9-20F2-48D4-89DA-8BEC7DF3A133}"/>
              </a:ext>
            </a:extLst>
          </p:cNvPr>
          <p:cNvSpPr txBox="1"/>
          <p:nvPr/>
        </p:nvSpPr>
        <p:spPr>
          <a:xfrm>
            <a:off x="821095" y="1068627"/>
            <a:ext cx="6400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l Table 1</a:t>
            </a: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. Anti-SARS-CoV-2 RBD antibody titer of 44 patients 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ultiple myeloma</a:t>
            </a: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one month after 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wo-dose SARS-CoV-2 mRNA vaccination</a:t>
            </a: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 by demographics and clinical characteristics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0C1A1F7-EBF6-4E44-B63F-2240425F322B}"/>
              </a:ext>
            </a:extLst>
          </p:cNvPr>
          <p:cNvSpPr txBox="1"/>
          <p:nvPr/>
        </p:nvSpPr>
        <p:spPr>
          <a:xfrm>
            <a:off x="821095" y="7027964"/>
            <a:ext cx="6400801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sults range from &lt;0.4 to &gt;250 U/mL with detectable antibody defined as an anti-SARS-CoV-2 RBD antibody titer &gt;0.79 U/mL by the manufacturer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ge was dichotomized into ≤55 and &gt;55 based on early vaccine trials (Ref. 4)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aseline="30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nce participants could report more than one therapy, the sum of the therapies is greater than the total N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05368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292</Words>
  <Application>Microsoft Office PowerPoint</Application>
  <PresentationFormat>Custom</PresentationFormat>
  <Paragraphs>5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s Greenberg</dc:creator>
  <cp:lastModifiedBy>Ross Greenberg</cp:lastModifiedBy>
  <cp:revision>2</cp:revision>
  <dcterms:created xsi:type="dcterms:W3CDTF">2021-05-26T13:59:55Z</dcterms:created>
  <dcterms:modified xsi:type="dcterms:W3CDTF">2021-06-10T19:40:33Z</dcterms:modified>
</cp:coreProperties>
</file>